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6" r:id="rId2"/>
  </p:sldIdLst>
  <p:sldSz cx="6858000" cy="9906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794" autoAdjust="0"/>
    <p:restoredTop sz="93321" autoAdjust="0"/>
  </p:normalViewPr>
  <p:slideViewPr>
    <p:cSldViewPr snapToGrid="0">
      <p:cViewPr>
        <p:scale>
          <a:sx n="120" d="100"/>
          <a:sy n="120" d="100"/>
        </p:scale>
        <p:origin x="-1552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41550" y="685800"/>
            <a:ext cx="23749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24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TW" noProof="0" smtClean="0"/>
              <a:t>Click to edit Master text styles</a:t>
            </a:r>
          </a:p>
          <a:p>
            <a:pPr lvl="1"/>
            <a:r>
              <a:rPr lang="en-US" altLang="zh-TW" noProof="0" smtClean="0"/>
              <a:t>Second level</a:t>
            </a:r>
          </a:p>
          <a:p>
            <a:pPr lvl="2"/>
            <a:r>
              <a:rPr lang="en-US" altLang="zh-TW" noProof="0" smtClean="0"/>
              <a:t>Third level</a:t>
            </a:r>
          </a:p>
          <a:p>
            <a:pPr lvl="3"/>
            <a:r>
              <a:rPr lang="en-US" altLang="zh-TW" noProof="0" smtClean="0"/>
              <a:t>Fourth level</a:t>
            </a:r>
          </a:p>
          <a:p>
            <a:pPr lvl="4"/>
            <a:r>
              <a:rPr lang="en-US" altLang="zh-TW" noProof="0" smtClean="0"/>
              <a:t>Fifth level</a:t>
            </a:r>
          </a:p>
        </p:txBody>
      </p:sp>
      <p:sp>
        <p:nvSpPr>
          <p:cNvPr id="1024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US" altLang="zh-TW"/>
          </a:p>
        </p:txBody>
      </p:sp>
      <p:sp>
        <p:nvSpPr>
          <p:cNvPr id="1024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F6FEE8A5-9C87-404D-8492-3C853F20A90D}" type="slidenum">
              <a:rPr lang="en-US" altLang="zh-TW"/>
              <a:pPr>
                <a:defRPr/>
              </a:pPr>
              <a:t>‹#›</a:t>
            </a:fld>
            <a:endParaRPr lang="en-US" altLang="zh-TW"/>
          </a:p>
        </p:txBody>
      </p:sp>
    </p:spTree>
    <p:extLst>
      <p:ext uri="{BB962C8B-B14F-4D97-AF65-F5344CB8AC3E}">
        <p14:creationId xmlns:p14="http://schemas.microsoft.com/office/powerpoint/2010/main" val="41835355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74A63721-D335-48B9-A825-E6ECD7AEE62F}" type="slidenum">
              <a:rPr lang="en-US"/>
              <a:pPr/>
              <a:t>1</a:t>
            </a:fld>
            <a:endParaRPr lang="en-US"/>
          </a:p>
        </p:txBody>
      </p:sp>
      <p:sp>
        <p:nvSpPr>
          <p:cNvPr id="2560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25603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S1.</a:t>
            </a:r>
            <a:r>
              <a:rPr lang="en-US" baseline="0" dirty="0" smtClean="0"/>
              <a:t> </a:t>
            </a:r>
            <a:r>
              <a:rPr lang="en-US" dirty="0" err="1" smtClean="0"/>
              <a:t>xGHRHR</a:t>
            </a:r>
            <a:endParaRPr 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50B5CD-6DC2-488A-8CC5-26D5D8EA5523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149FED-75D0-45AD-9203-57757DA7824A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B65793E-BAEE-4E76-B02D-E7F84C96FA4F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1419A11-772A-478B-A406-204C2CA1E962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B835CCB-5A45-4F3B-BF4D-E2D1D6C69DAF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F3FA01D-0F3C-4919-A15A-DBB85F6733EB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BADBFA8-76EC-40D1-B098-741747C39A09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C099D5-CB82-4CF4-A69C-34954EBB4238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542DEF1-D662-4568-A474-6A49013C4D6C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64925D-2209-4F52-942B-99DE92B0048E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A488043-628A-48BA-822F-0DA4A964B997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90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B0786B7A-7858-4DC6-8659-885DA40587B3}" type="slidenum">
              <a:rPr lang="en-US">
                <a:solidFill>
                  <a:srgbClr val="000000"/>
                </a:solidFill>
              </a:rPr>
              <a:pPr/>
              <a:t>‹#›</a:t>
            </a:fld>
            <a:endParaRPr lang="en-US">
              <a:solidFill>
                <a:srgbClr val="000000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>
            <a:grpSpLocks/>
          </p:cNvGrpSpPr>
          <p:nvPr/>
        </p:nvGrpSpPr>
        <p:grpSpPr bwMode="auto">
          <a:xfrm>
            <a:off x="-533400" y="441325"/>
            <a:ext cx="7483475" cy="7337425"/>
            <a:chOff x="-336" y="278"/>
            <a:chExt cx="4714" cy="4622"/>
          </a:xfrm>
        </p:grpSpPr>
        <p:grpSp>
          <p:nvGrpSpPr>
            <p:cNvPr id="3" name="Group 3"/>
            <p:cNvGrpSpPr>
              <a:grpSpLocks/>
            </p:cNvGrpSpPr>
            <p:nvPr/>
          </p:nvGrpSpPr>
          <p:grpSpPr bwMode="auto">
            <a:xfrm>
              <a:off x="-336" y="278"/>
              <a:ext cx="4714" cy="4622"/>
              <a:chOff x="-336" y="278"/>
              <a:chExt cx="4714" cy="4622"/>
            </a:xfrm>
          </p:grpSpPr>
          <p:grpSp>
            <p:nvGrpSpPr>
              <p:cNvPr id="4" name="Group 4"/>
              <p:cNvGrpSpPr>
                <a:grpSpLocks/>
              </p:cNvGrpSpPr>
              <p:nvPr/>
            </p:nvGrpSpPr>
            <p:grpSpPr bwMode="auto">
              <a:xfrm>
                <a:off x="-336" y="460"/>
                <a:ext cx="4714" cy="4440"/>
                <a:chOff x="-336" y="460"/>
                <a:chExt cx="4714" cy="4440"/>
              </a:xfrm>
            </p:grpSpPr>
            <p:sp>
              <p:nvSpPr>
                <p:cNvPr id="24581" name="Rectangle 5"/>
                <p:cNvSpPr>
                  <a:spLocks noChangeArrowheads="1"/>
                </p:cNvSpPr>
                <p:nvPr/>
              </p:nvSpPr>
              <p:spPr bwMode="auto">
                <a:xfrm>
                  <a:off x="-336" y="480"/>
                  <a:ext cx="4512" cy="44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spAutoFit/>
                </a:bodyPr>
                <a:lstStyle/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Courier New" pitchFamily="49" charset="0"/>
                    </a:rPr>
                    <a:t>M   </a:t>
                  </a:r>
                  <a:r>
                    <a:rPr lang="en-US" sz="1000" b="1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M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Courier New" pitchFamily="49" charset="0"/>
                    </a:rPr>
                    <a:t>   T   S   T   F   L   H   A   G   A   W   L   H   F   L   </a:t>
                  </a:r>
                  <a:r>
                    <a:rPr lang="en-US" sz="1000" b="1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L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Courier New" pitchFamily="49" charset="0"/>
                    </a:rPr>
                    <a:t>   I   L   M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  1	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Courier New" pitchFamily="49" charset="0"/>
                    </a:rPr>
                    <a:t>ATG </a:t>
                  </a:r>
                  <a:r>
                    <a:rPr lang="en-US" sz="1000" b="1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ATG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Courier New" pitchFamily="49" charset="0"/>
                    </a:rPr>
                    <a:t> ACT TCA ACC TTC CTA CAC GCT GGA GCC TGG CTG CAC TTC TTA CTG ATT CTG ATG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Courier New" pitchFamily="49" charset="0"/>
                    </a:rPr>
                    <a:t>G   L   S   W   K   Q   V   S   C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T   H   P   E   C   A   L   V   L   Q   V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 61	</a:t>
                  </a:r>
                  <a:r>
                    <a:rPr lang="en-US" sz="1000" b="1" dirty="0">
                      <a:solidFill>
                        <a:srgbClr val="000000"/>
                      </a:solidFill>
                      <a:latin typeface="Courier New" pitchFamily="49" charset="0"/>
                    </a:rPr>
                    <a:t>GGT TTA TCC TGG AAG CAG GTG AGC TGC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ACA CAC CCA GAA TGT GCC CTT GTA CTT CAG GTT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L   E   Q   E   A   Q   C   Y   E   R   I   K   S   E   N   T   S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S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R   N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12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TTG GAA CAA GAG GCT CAG TGT TAT GAG AGG ATA AAA TCT GAG AAT ACA AGT TCA CGC AAT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S   T   H   G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G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C   N   M   E   W   D   G   V   N   C   W   S   A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A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S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18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TCC ACC CAT GGA GGC TGT AAC ATG GAG TGG GAT GGA GTG AAC TGC TGG AGT GCT GCC TCA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I   G   Q   T   V   T   V   S   C   P   E   S   L   Q   M   F   L   N   S   K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24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ATA GGA CAA ACT GTG ACA GTC TCC TGC CCG GAG AGC TTG CAG ATG TTT CTG AAC TCA AAA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V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V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I   S   R   N   C   S   E   D   G   W   T   P   H   S   P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P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Y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Y</a:t>
                  </a:r>
                  <a:endParaRPr lang="en-US" sz="1000" dirty="0">
                    <a:solidFill>
                      <a:srgbClr val="000000"/>
                    </a:solidFill>
                    <a:latin typeface="Courier New" pitchFamily="49" charset="0"/>
                  </a:endParaRP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30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GTT GTG ATC AGC AGA AAC TGC TCA GAG GAC GGA TGG ACC CCT CAC TCC CCT CCG TAT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TAT</a:t>
                  </a:r>
                  <a:endParaRPr lang="en-US" sz="1000" dirty="0">
                    <a:solidFill>
                      <a:srgbClr val="000000"/>
                    </a:solidFill>
                    <a:latin typeface="Courier New" pitchFamily="49" charset="0"/>
                  </a:endParaRP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K   A   C   I   F   S   G   T   N   E   T   D   E   K   G   N   Y   F   H   T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36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AAA GCC TGC ATA TTC AGT GGA ACC AAT GAG ACC GAC GAA AAG GGA AAT TAT TTC CAT ACG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V   K   I  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L   Y   T   C   G   Y   A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A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S   L   T   A   L   V   T   A   I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42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GTG AAA ATC CTG TAT ACG TGC GGC TAT GCA GCT TCC CTT ACT GCT CTC GTG ACT GCC ATC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S   I   F   S   L   F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R   K   L   H   C   P   R   N   F   I   H  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V   N   L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48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AGC ATC TTC TCC CTC TTC AGG AAA CTG CAC TGC CCC AGG AAC TTC ATC CAT GTC AAC CTC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F   V   S   F   I   L   R   G   I   A   V   F   I   K   D   A   V   L   F   A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54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TTT GTC TCG TTC ATC CTC CGT GGA ATC GCT GTG TTT ATT AAA GAC GCT GTT CTC TTT GCC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D   E   N   V   D   H   C   T   M   S   T   V   G   C   K   A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A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V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V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F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60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GAT GAG AAT GTA GAC CAC TGT ACC ATG TCA ACG GTG GGC TGT AAG GCA GCT GTA GTG TTT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F   Q   Y   S   V   L   A   N   F   S   W   L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L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V   E   G   M   Y   L   H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66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TTC CAA TAC TCA GTC CTT GCA AAC TTT TCT TGG CTG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CTG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GTG GAA GGA ATG TAT CTA CAC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T   L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L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T   L   T   F   T   Y   Q   R   K   Y  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F   W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W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Y   I   V   I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72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ACT TTG CTC ACA CTC ACT TTT ACT TAC CAG AGA AAA TAC TTC TGG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TGG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TAT ATA GTC ATT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G   W   G   A   P   A   L   T   I   S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V   W   I   K   T   R   I   Q   F   D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78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GGA TGG GGT GCC CCA GCT CTC ACC ATT TCA GTA TGG ATC AAA ACA AGA ATT CAG TTT GAC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N   T   G   C   W   D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D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Y   E   S   I   Y  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W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W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I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I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K   T   P   I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84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AAT ACA GGG TGC TGG GAT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GAT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TAT GAG AGC ATT TAC TGG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TGG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ATA ATC AAG ACC CCA ATA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L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L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A   I   F   I   N   F   I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I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F   L   N   V   I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R   I   L   I   Q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90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CTG CTT GCA ATA TTT ATC AAC TTC ATC ATA TTT CTC AAT GTG ATC AGA ATT CTT ATC CAG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K   I   R   C   P   D   I   S   K   N   Y   K   Q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Q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Y   M   R   L   A   K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 96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AAG ATA CGA TGC CCA GAT ATC AGC AAA AAT TAT AAA CAG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CAG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TAC ATG AGA CTC GCA AAG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S   T   L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L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L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I   P   L   F   G   V   H   Y   V   I   F   A   L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F   P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102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TCT ACT CTT CTC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CTC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ATC CCT CTG TTT GGG GTT CAT TAT GTT ATC TTC GCA CTG TTT CCG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E   H   I   G   I   W   A  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R   M   Y   F   E   L   V   L   G   S   N   Q   G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108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GAG CAC ATC GGT ATT TGG GCA CGA ATG TAC TTT GAA CTT GTT CTT GGA TCC AAT CAG GGA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F   I   V   A   L   </a:t>
                  </a:r>
                  <a:r>
                    <a:rPr lang="en-US" sz="1000" u="sng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L</a:t>
                  </a:r>
                  <a:r>
                    <a:rPr lang="en-US" sz="1000" u="sng" dirty="0">
                      <a:solidFill>
                        <a:srgbClr val="000000"/>
                      </a:solidFill>
                      <a:latin typeface="Courier New" pitchFamily="49" charset="0"/>
                    </a:rPr>
                    <a:t>   Y   C   F   L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N   G   E   V   Q   A   E   I   Q   R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114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TTC ATA GTG GCT TTG CTC TAC TGC TTC CTC AAT GGA GAG GTC CAG GCG GAG ATC CAG AGG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H   W   G   K   W   Q   S   </a:t>
                  </a:r>
                  <a:r>
                    <a:rPr lang="en-US" sz="1000" dirty="0" err="1">
                      <a:solidFill>
                        <a:srgbClr val="000000"/>
                      </a:solidFill>
                      <a:latin typeface="Courier New" pitchFamily="49" charset="0"/>
                    </a:rPr>
                    <a:t>S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  L   E   S   N   V   F   N   L   V   T   Q   D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120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CAC TGG GGC AAG TGG CAG AGC TCA TTA GAG AGC AAC GTA TTT AAC CTG GTG ACA CAA GAC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 F   T   A   *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1261	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TTC ACA GCA TAAagtcataggcactgaagatgcaaagaagaccttttaggatggtacaaagcgcaaagaagacctt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1337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ttagggtgctacaaagcagggctaaccgtaaacccggcaaaaattaaatgcagagcttgctatgntatttatcaagcaa       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1416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caacccatcaactcttcattgggccccctcttatcatcagctatgacacaagttgcattgtgctcggtttctaatgaca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</a:t>
                  </a: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1495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tcatgagtctatccatagtgagtggaatatagaagtccaattggggggtttgcagtctccaaaagctggtaatgatagc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1574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aatgtacctagacccttttgaggaatctgtctgcatcatactgatgcgngttttcatcataccccttcatctgctataa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 1653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	gtacccccataatctctttgtcctaacaatttcaccccatattaaggggcatattgtatttaaactctgaacttaaaaa</a:t>
                  </a:r>
                </a:p>
                <a:p>
                  <a:pPr lvl="1">
                    <a:lnSpc>
                      <a:spcPct val="90000"/>
                    </a:lnSpc>
                  </a:pP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</a:t>
                  </a:r>
                  <a:r>
                    <a:rPr lang="en-US" sz="1000" dirty="0">
                      <a:solidFill>
                        <a:srgbClr val="800000"/>
                      </a:solidFill>
                      <a:latin typeface="Courier New" pitchFamily="49" charset="0"/>
                    </a:rPr>
                    <a:t>1732</a:t>
                  </a:r>
                  <a:r>
                    <a:rPr lang="en-US" sz="1000" dirty="0">
                      <a:solidFill>
                        <a:srgbClr val="000000"/>
                      </a:solidFill>
                      <a:latin typeface="Courier New" pitchFamily="49" charset="0"/>
                    </a:rPr>
                    <a:t> </a:t>
                  </a:r>
                  <a:r>
                    <a:rPr lang="en-US" sz="1000" dirty="0" err="1" smtClean="0">
                      <a:solidFill>
                        <a:srgbClr val="000000"/>
                      </a:solidFill>
                      <a:latin typeface="Courier New" pitchFamily="49" charset="0"/>
                    </a:rPr>
                    <a:t>aaaaaaaaaaaaaaaaa</a:t>
                  </a:r>
                  <a:endParaRPr lang="en-US" sz="1000" dirty="0">
                    <a:solidFill>
                      <a:srgbClr val="000000"/>
                    </a:solidFill>
                    <a:latin typeface="Courier New" pitchFamily="49" charset="0"/>
                  </a:endParaRPr>
                </a:p>
              </p:txBody>
            </p:sp>
            <p:sp>
              <p:nvSpPr>
                <p:cNvPr id="24582" name="Text Box 6"/>
                <p:cNvSpPr txBox="1">
                  <a:spLocks noChangeArrowheads="1"/>
                </p:cNvSpPr>
                <p:nvPr/>
              </p:nvSpPr>
              <p:spPr bwMode="auto">
                <a:xfrm>
                  <a:off x="4042" y="460"/>
                  <a:ext cx="336" cy="37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  <p:txBody>
                <a:bodyPr>
                  <a:spAutoFit/>
                </a:bodyPr>
                <a:lstStyle/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2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4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6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8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10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12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14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16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18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20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22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24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26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28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30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32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34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36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38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40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420</a:t>
                  </a:r>
                </a:p>
                <a:p>
                  <a:pPr>
                    <a:lnSpc>
                      <a:spcPct val="129000"/>
                    </a:lnSpc>
                    <a:spcBef>
                      <a:spcPct val="50000"/>
                    </a:spcBef>
                  </a:pPr>
                  <a:r>
                    <a:rPr lang="en-US" sz="1000">
                      <a:solidFill>
                        <a:srgbClr val="800000"/>
                      </a:solidFill>
                      <a:latin typeface="Courier New" pitchFamily="49" charset="0"/>
                    </a:rPr>
                    <a:t>+423</a:t>
                  </a:r>
                </a:p>
              </p:txBody>
            </p:sp>
          </p:grpSp>
          <p:sp>
            <p:nvSpPr>
              <p:cNvPr id="24583" name="Rectangle 7"/>
              <p:cNvSpPr>
                <a:spLocks noChangeArrowheads="1"/>
              </p:cNvSpPr>
              <p:nvPr/>
            </p:nvSpPr>
            <p:spPr bwMode="auto">
              <a:xfrm>
                <a:off x="0" y="278"/>
                <a:ext cx="4148" cy="2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>
                <a:spAutoFit/>
              </a:bodyPr>
              <a:lstStyle/>
              <a:p>
                <a:pPr algn="r"/>
                <a:r>
                  <a:rPr lang="en-US" sz="1000" dirty="0" smtClean="0">
                    <a:solidFill>
                      <a:srgbClr val="800000"/>
                    </a:solidFill>
                    <a:latin typeface="Courier New" pitchFamily="49" charset="0"/>
                  </a:rPr>
                  <a:t>-98                                                             </a:t>
                </a:r>
                <a:r>
                  <a:rPr lang="en-US" sz="1000" dirty="0" err="1" smtClean="0">
                    <a:latin typeface="Courier New" pitchFamily="49" charset="0"/>
                  </a:rPr>
                  <a:t>ggaaaagattcggaaaaca</a:t>
                </a:r>
                <a:endParaRPr lang="en-US" sz="1000" dirty="0">
                  <a:latin typeface="Courier New" pitchFamily="49" charset="0"/>
                </a:endParaRPr>
              </a:p>
              <a:p>
                <a:pPr algn="r"/>
                <a:r>
                  <a:rPr lang="en-US" sz="1000" dirty="0">
                    <a:solidFill>
                      <a:srgbClr val="800000"/>
                    </a:solidFill>
                    <a:latin typeface="Courier New" pitchFamily="49" charset="0"/>
                  </a:rPr>
                  <a:t>-79</a:t>
                </a:r>
                <a:r>
                  <a:rPr lang="en-US" sz="1000" dirty="0">
                    <a:latin typeface="Courier New" pitchFamily="49" charset="0"/>
                  </a:rPr>
                  <a:t> gaatgtgaattctccaaacagaaccagctggatgcttaaaattggaaccgtggagccaatgacaccataaaagaacttg</a:t>
                </a:r>
              </a:p>
            </p:txBody>
          </p:sp>
        </p:grpSp>
        <p:sp>
          <p:nvSpPr>
            <p:cNvPr id="24584" name="Rectangle 8"/>
            <p:cNvSpPr>
              <a:spLocks noChangeArrowheads="1"/>
            </p:cNvSpPr>
            <p:nvPr/>
          </p:nvSpPr>
          <p:spPr bwMode="auto">
            <a:xfrm>
              <a:off x="708" y="1641"/>
              <a:ext cx="27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/>
                <a:t>TM1</a:t>
              </a:r>
            </a:p>
          </p:txBody>
        </p:sp>
        <p:sp>
          <p:nvSpPr>
            <p:cNvPr id="24585" name="Rectangle 9"/>
            <p:cNvSpPr>
              <a:spLocks noChangeArrowheads="1"/>
            </p:cNvSpPr>
            <p:nvPr/>
          </p:nvSpPr>
          <p:spPr bwMode="auto">
            <a:xfrm>
              <a:off x="3397" y="1814"/>
              <a:ext cx="27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/>
                <a:t>TM2</a:t>
              </a:r>
            </a:p>
          </p:txBody>
        </p:sp>
        <p:sp>
          <p:nvSpPr>
            <p:cNvPr id="24586" name="Rectangle 10"/>
            <p:cNvSpPr>
              <a:spLocks noChangeArrowheads="1"/>
            </p:cNvSpPr>
            <p:nvPr/>
          </p:nvSpPr>
          <p:spPr bwMode="auto">
            <a:xfrm>
              <a:off x="3783" y="2150"/>
              <a:ext cx="27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/>
                <a:t>TM3</a:t>
              </a:r>
            </a:p>
          </p:txBody>
        </p:sp>
        <p:sp>
          <p:nvSpPr>
            <p:cNvPr id="24587" name="Rectangle 11"/>
            <p:cNvSpPr>
              <a:spLocks noChangeArrowheads="1"/>
            </p:cNvSpPr>
            <p:nvPr/>
          </p:nvSpPr>
          <p:spPr bwMode="auto">
            <a:xfrm>
              <a:off x="2625" y="2496"/>
              <a:ext cx="27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/>
                <a:t>TM4</a:t>
              </a:r>
            </a:p>
          </p:txBody>
        </p:sp>
        <p:sp>
          <p:nvSpPr>
            <p:cNvPr id="24588" name="Rectangle 12"/>
            <p:cNvSpPr>
              <a:spLocks noChangeArrowheads="1"/>
            </p:cNvSpPr>
            <p:nvPr/>
          </p:nvSpPr>
          <p:spPr bwMode="auto">
            <a:xfrm>
              <a:off x="2435" y="2844"/>
              <a:ext cx="27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/>
                <a:t>TM5</a:t>
              </a:r>
            </a:p>
          </p:txBody>
        </p:sp>
        <p:sp>
          <p:nvSpPr>
            <p:cNvPr id="24589" name="Rectangle 13"/>
            <p:cNvSpPr>
              <a:spLocks noChangeArrowheads="1"/>
            </p:cNvSpPr>
            <p:nvPr/>
          </p:nvSpPr>
          <p:spPr bwMode="auto">
            <a:xfrm>
              <a:off x="132" y="3362"/>
              <a:ext cx="27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/>
                <a:t>TM6</a:t>
              </a:r>
            </a:p>
          </p:txBody>
        </p:sp>
        <p:sp>
          <p:nvSpPr>
            <p:cNvPr id="24590" name="Rectangle 14"/>
            <p:cNvSpPr>
              <a:spLocks noChangeArrowheads="1"/>
            </p:cNvSpPr>
            <p:nvPr/>
          </p:nvSpPr>
          <p:spPr bwMode="auto">
            <a:xfrm>
              <a:off x="1462" y="3542"/>
              <a:ext cx="27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1000" b="1" i="1"/>
                <a:t>TM7</a:t>
              </a:r>
            </a:p>
          </p:txBody>
        </p:sp>
      </p:grpSp>
      <p:sp>
        <p:nvSpPr>
          <p:cNvPr id="15" name="Text Box 4"/>
          <p:cNvSpPr txBox="1">
            <a:spLocks noChangeArrowheads="1"/>
          </p:cNvSpPr>
          <p:nvPr/>
        </p:nvSpPr>
        <p:spPr bwMode="auto">
          <a:xfrm>
            <a:off x="-22225" y="-15552"/>
            <a:ext cx="1579563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TW" sz="1400" b="1" dirty="0" smtClean="0">
                <a:ea typeface="新細明體" pitchFamily="18" charset="-120"/>
              </a:rPr>
              <a:t>FIGURE S1</a:t>
            </a:r>
            <a:endParaRPr lang="en-US" altLang="zh-TW" sz="1400" b="1" dirty="0">
              <a:ea typeface="新細明體" pitchFamily="18" charset="-12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佈景主題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4</TotalTime>
  <Words>64</Words>
  <Application>Microsoft Macintosh PowerPoint</Application>
  <PresentationFormat>A4 Paper (210x297 mm)</PresentationFormat>
  <Paragraphs>8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Default 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M KAL VAN</dc:creator>
  <cp:lastModifiedBy>Leo T.O. Lee</cp:lastModifiedBy>
  <cp:revision>228</cp:revision>
  <dcterms:created xsi:type="dcterms:W3CDTF">2010-04-22T03:44:22Z</dcterms:created>
  <dcterms:modified xsi:type="dcterms:W3CDTF">2012-12-04T02:55:36Z</dcterms:modified>
</cp:coreProperties>
</file>